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7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76" autoAdjust="0"/>
    <p:restoredTop sz="92986" autoAdjust="0"/>
  </p:normalViewPr>
  <p:slideViewPr>
    <p:cSldViewPr snapToGrid="0" snapToObjects="1">
      <p:cViewPr varScale="1">
        <p:scale>
          <a:sx n="59" d="100"/>
          <a:sy n="59" d="100"/>
        </p:scale>
        <p:origin x="2892" y="72"/>
      </p:cViewPr>
      <p:guideLst>
        <p:guide orient="horz" pos="336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263235-826B-4DBE-BF6E-0C185A76ABA3}" type="datetimeFigureOut">
              <a:rPr lang="zh-CN" altLang="en-US" smtClean="0"/>
              <a:pPr/>
              <a:t>2018/8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50AFE5-DE01-4638-B01A-C45FD2F995A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84380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1pPr>
    <a:lvl2pPr marL="521437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2pPr>
    <a:lvl3pPr marL="104287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3pPr>
    <a:lvl4pPr marL="156431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4pPr>
    <a:lvl5pPr marL="208574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5pPr>
    <a:lvl6pPr marL="260718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6pPr>
    <a:lvl7pPr marL="3128620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7pPr>
    <a:lvl8pPr marL="3650056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8pPr>
    <a:lvl9pPr marL="4171493" algn="l" defTabSz="1042873" rtl="0" eaLnBrk="1" latinLnBrk="0" hangingPunct="1">
      <a:defRPr sz="136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64587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4928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14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24444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8165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4322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5903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487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0986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841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0664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332352-35CF-C541-BAAE-15B5B662B3CC}" type="datetimeFigureOut">
              <a:rPr lang="en-US" smtClean="0"/>
              <a:pPr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EF85BC-BD8C-884D-B314-D424980EBE1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239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19" t="4963" r="20382" b="7120"/>
          <a:stretch/>
        </p:blipFill>
        <p:spPr>
          <a:xfrm>
            <a:off x="2873017" y="1821487"/>
            <a:ext cx="3318714" cy="4299244"/>
          </a:xfrm>
        </p:spPr>
      </p:pic>
      <p:sp>
        <p:nvSpPr>
          <p:cNvPr id="3" name="文本框 2"/>
          <p:cNvSpPr txBox="1"/>
          <p:nvPr/>
        </p:nvSpPr>
        <p:spPr>
          <a:xfrm>
            <a:off x="6089775" y="3612852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logical process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6089775" y="3820337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component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48"/>
          <p:cNvSpPr txBox="1"/>
          <p:nvPr/>
        </p:nvSpPr>
        <p:spPr>
          <a:xfrm>
            <a:off x="6089775" y="4024604"/>
            <a:ext cx="2284845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function</a:t>
            </a:r>
            <a:endParaRPr lang="zh-CN" altLang="en-US" sz="132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805382" y="1846878"/>
            <a:ext cx="219790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ulatio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ranscription, DNA-</a:t>
            </a:r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mplated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1429355" y="2049029"/>
            <a:ext cx="1587646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ctio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external stimulu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695005" y="2258037"/>
            <a:ext cx="128771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pid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bolic proces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966044" y="2464208"/>
            <a:ext cx="1145379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se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water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1957326" y="2674269"/>
            <a:ext cx="114195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onse to chitin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1412696" y="2891542"/>
            <a:ext cx="1564852" cy="22807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rug </a:t>
            </a:r>
            <a:r>
              <a: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membrane transport</a:t>
            </a:r>
          </a:p>
        </p:txBody>
      </p:sp>
      <p:sp>
        <p:nvSpPr>
          <p:cNvPr id="12" name="矩形 11"/>
          <p:cNvSpPr/>
          <p:nvPr/>
        </p:nvSpPr>
        <p:spPr>
          <a:xfrm>
            <a:off x="1524786" y="3096660"/>
            <a:ext cx="1454244" cy="22807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ral </a:t>
            </a:r>
            <a:r>
              <a: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orl morphogenesis</a:t>
            </a:r>
          </a:p>
        </p:txBody>
      </p:sp>
      <p:sp>
        <p:nvSpPr>
          <p:cNvPr id="13" name="矩形 12"/>
          <p:cNvSpPr/>
          <p:nvPr/>
        </p:nvSpPr>
        <p:spPr>
          <a:xfrm>
            <a:off x="1285816" y="3294417"/>
            <a:ext cx="1688283" cy="22807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ntegral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onent of membrane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2415460" y="3512462"/>
            <a:ext cx="553357" cy="22807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us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93302" y="3716151"/>
            <a:ext cx="2951016" cy="2280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-specific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A binding transcription factor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矩形 15"/>
          <p:cNvSpPr/>
          <p:nvPr/>
        </p:nvSpPr>
        <p:spPr>
          <a:xfrm>
            <a:off x="1333793" y="3921891"/>
            <a:ext cx="1648208" cy="22807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equence</a:t>
            </a:r>
            <a:r>
              <a: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pecific DNA binding</a:t>
            </a:r>
          </a:p>
        </p:txBody>
      </p:sp>
      <p:sp>
        <p:nvSpPr>
          <p:cNvPr id="17" name="矩形 16"/>
          <p:cNvSpPr/>
          <p:nvPr/>
        </p:nvSpPr>
        <p:spPr>
          <a:xfrm>
            <a:off x="776479" y="4117263"/>
            <a:ext cx="2209259" cy="22807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ine/threonine phosphatase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矩形 17"/>
          <p:cNvSpPr/>
          <p:nvPr/>
        </p:nvSpPr>
        <p:spPr>
          <a:xfrm>
            <a:off x="1881654" y="4345939"/>
            <a:ext cx="1091966" cy="22807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8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lmodulin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nding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1032266" y="4554402"/>
            <a:ext cx="1947969" cy="22807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ine/threonine kinase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500838" y="4755596"/>
            <a:ext cx="2489784" cy="22807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ium-chain-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)-2-hydroxy-acid oxidase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422742" y="4963703"/>
            <a:ext cx="2666398" cy="2280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r>
              <a: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y</a:t>
            </a:r>
            <a:r>
              <a: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ong-chain-(S)-2-hydroxy-acid oxidase activity</a:t>
            </a:r>
          </a:p>
        </p:txBody>
      </p:sp>
      <p:sp>
        <p:nvSpPr>
          <p:cNvPr id="22" name="矩形 21"/>
          <p:cNvSpPr/>
          <p:nvPr/>
        </p:nvSpPr>
        <p:spPr>
          <a:xfrm>
            <a:off x="130072" y="5174431"/>
            <a:ext cx="3779838" cy="228076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g</a:t>
            </a:r>
            <a:r>
              <a: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hain-(S)-2-hydroxy-long-chain-acid oxidase activity</a:t>
            </a:r>
          </a:p>
        </p:txBody>
      </p:sp>
      <p:sp>
        <p:nvSpPr>
          <p:cNvPr id="23" name="矩形 22"/>
          <p:cNvSpPr/>
          <p:nvPr/>
        </p:nvSpPr>
        <p:spPr>
          <a:xfrm>
            <a:off x="-23170" y="5386901"/>
            <a:ext cx="3060740" cy="2280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tamine</a:t>
            </a:r>
            <a:r>
              <a: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ructose-6-phosphate transaminase (isomerizing) </a:t>
            </a:r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…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矩形 23"/>
          <p:cNvSpPr/>
          <p:nvPr/>
        </p:nvSpPr>
        <p:spPr>
          <a:xfrm>
            <a:off x="776479" y="5599137"/>
            <a:ext cx="2319517" cy="2280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yloglucan:xyloglucosyl transferase activity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矩形 24"/>
          <p:cNvSpPr/>
          <p:nvPr/>
        </p:nvSpPr>
        <p:spPr>
          <a:xfrm>
            <a:off x="1869031" y="5805907"/>
            <a:ext cx="1114408" cy="22807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cium </a:t>
            </a:r>
            <a:r>
              <a:rPr lang="zh-CN" altLang="en-US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ion binding</a:t>
            </a:r>
          </a:p>
        </p:txBody>
      </p:sp>
      <p:sp>
        <p:nvSpPr>
          <p:cNvPr id="26" name="文本框 25"/>
          <p:cNvSpPr txBox="1"/>
          <p:nvPr/>
        </p:nvSpPr>
        <p:spPr>
          <a:xfrm>
            <a:off x="2888894" y="6047836"/>
            <a:ext cx="414204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3643646" y="6054079"/>
            <a:ext cx="41998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6"/>
          <p:cNvSpPr txBox="1"/>
          <p:nvPr/>
        </p:nvSpPr>
        <p:spPr>
          <a:xfrm>
            <a:off x="5067614" y="6048756"/>
            <a:ext cx="41998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6"/>
          <p:cNvSpPr txBox="1"/>
          <p:nvPr/>
        </p:nvSpPr>
        <p:spPr>
          <a:xfrm>
            <a:off x="4359096" y="6050957"/>
            <a:ext cx="296752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48"/>
          <p:cNvSpPr txBox="1"/>
          <p:nvPr/>
        </p:nvSpPr>
        <p:spPr>
          <a:xfrm>
            <a:off x="3680801" y="6235022"/>
            <a:ext cx="1252566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og10(</a:t>
            </a:r>
            <a:r>
              <a:rPr lang="en-US" altLang="zh-CN" sz="1323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value</a:t>
            </a:r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sz="132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48"/>
          <p:cNvSpPr txBox="1"/>
          <p:nvPr/>
        </p:nvSpPr>
        <p:spPr>
          <a:xfrm>
            <a:off x="3155133" y="1554526"/>
            <a:ext cx="2648440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32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ost enriched GO terms</a:t>
            </a:r>
            <a:endParaRPr lang="zh-CN" altLang="en-US" sz="1323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5401222" y="1859865"/>
            <a:ext cx="3518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3613247" y="2070652"/>
            <a:ext cx="3518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3430456" y="2280713"/>
            <a:ext cx="3518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3461321" y="2489844"/>
            <a:ext cx="3518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3390098" y="2699906"/>
            <a:ext cx="252751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3392763" y="2901250"/>
            <a:ext cx="3518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3392763" y="3120754"/>
            <a:ext cx="3518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4049915" y="3330100"/>
            <a:ext cx="404358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3708179" y="3532160"/>
            <a:ext cx="3518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81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3859746" y="3735038"/>
            <a:ext cx="3518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6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3834872" y="3954144"/>
            <a:ext cx="3518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3794830" y="4158235"/>
            <a:ext cx="3518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3782214" y="4360721"/>
            <a:ext cx="3518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3525652" y="4576731"/>
            <a:ext cx="3518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3535424" y="4779374"/>
            <a:ext cx="3518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3544499" y="4995156"/>
            <a:ext cx="3518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3535421" y="5196656"/>
            <a:ext cx="3518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3532245" y="5406665"/>
            <a:ext cx="3518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3456676" y="5614107"/>
            <a:ext cx="3518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3401838" y="5814988"/>
            <a:ext cx="351867" cy="22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82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sz="882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TextBox 3"/>
          <p:cNvSpPr txBox="1"/>
          <p:nvPr/>
        </p:nvSpPr>
        <p:spPr>
          <a:xfrm flipH="1">
            <a:off x="-1" y="322299"/>
            <a:ext cx="1302416" cy="295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323" b="1" dirty="0">
                <a:latin typeface="Times New Roman" panose="02020603050405020304" pitchFamily="18" charset="0"/>
                <a:ea typeface="Arial" charset="0"/>
                <a:cs typeface="Times New Roman" panose="02020603050405020304" pitchFamily="18" charset="0"/>
              </a:rPr>
              <a:t>Fig. S8</a:t>
            </a:r>
            <a:endParaRPr lang="en-US" sz="1323" b="1" dirty="0">
              <a:latin typeface="Times New Roman" panose="02020603050405020304" pitchFamily="18" charset="0"/>
              <a:ea typeface="Arial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55627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63</TotalTime>
  <Words>158</Words>
  <Application>Microsoft Office PowerPoint</Application>
  <PresentationFormat>自定义</PresentationFormat>
  <Paragraphs>5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yzyangyan</cp:lastModifiedBy>
  <cp:revision>159</cp:revision>
  <dcterms:created xsi:type="dcterms:W3CDTF">2017-02-03T22:12:08Z</dcterms:created>
  <dcterms:modified xsi:type="dcterms:W3CDTF">2018-08-23T04:45:22Z</dcterms:modified>
</cp:coreProperties>
</file>